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138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7BA637-1434-41A4-9344-637F73F7142A}" type="datetimeFigureOut">
              <a:rPr lang="it-IT" smtClean="0"/>
              <a:pPr/>
              <a:t>23/03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C4E74-F4B7-4AC0-9026-A5D3329731F7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Segnaposto contenuto 3"/>
          <p:cNvGraphicFramePr>
            <a:graphicFrameLocks noGrp="1"/>
          </p:cNvGraphicFramePr>
          <p:nvPr>
            <p:ph idx="1"/>
          </p:nvPr>
        </p:nvGraphicFramePr>
        <p:xfrm>
          <a:off x="1837223" y="1115568"/>
          <a:ext cx="5469555" cy="4626864"/>
        </p:xfrm>
        <a:graphic>
          <a:graphicData uri="http://schemas.openxmlformats.org/drawingml/2006/table">
            <a:tbl>
              <a:tblPr/>
              <a:tblGrid>
                <a:gridCol w="1514576"/>
                <a:gridCol w="3954979"/>
              </a:tblGrid>
              <a:tr h="188582">
                <a:tc gridSpan="2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latin typeface="Arial"/>
                          <a:ea typeface="Batang"/>
                          <a:cs typeface="Times New Roman"/>
                        </a:rPr>
                        <a:t>Supplementary Table 1</a:t>
                      </a:r>
                      <a:r>
                        <a:rPr lang="en-US" sz="1100" b="1" dirty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 Antibody</a:t>
                      </a:r>
                      <a:endParaRPr lang="it-IT" sz="1100" b="1" dirty="0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Antibody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latin typeface="Arial"/>
                          <a:ea typeface="Batang"/>
                          <a:cs typeface="Times New Roman"/>
                        </a:rPr>
                        <a:t>Manufacturer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13-FITC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Ancell (MN, USA)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44-FITC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45-FITC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29-PE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105-FITC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166-FITC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14-FITC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Miltenyi Biotec (Bergisch Gladbach, Germany);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133-FITC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HLA-DR-PE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Becton Dickinson (San Jose, CA, USA)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HLA-ABC-Alexa488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31-FITC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90-FITC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73-PE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326-PE-Cy5,5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NANOG-PE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SOX2-Alexa488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SSEA4-FITC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OCT3/4-PE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117-APC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8858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D34-PE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Beckman Coulter (Fullerton, CA, USA)</a:t>
                      </a:r>
                      <a:endParaRPr lang="it-IT" sz="1100" b="1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7164">
                <a:tc gridSpan="2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 err="1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Fluorescein</a:t>
                      </a: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 </a:t>
                      </a:r>
                      <a:r>
                        <a:rPr lang="en-US" sz="1100" b="0" dirty="0" err="1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isothiocyanate</a:t>
                      </a: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 (FITC); </a:t>
                      </a:r>
                      <a:r>
                        <a:rPr lang="en-US" sz="1100" b="0" dirty="0" err="1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Phycoerythrin</a:t>
                      </a: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 (PE); </a:t>
                      </a:r>
                      <a:r>
                        <a:rPr lang="en-US" sz="1100" b="0" dirty="0" err="1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Cyanin</a:t>
                      </a: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 (Cy); </a:t>
                      </a:r>
                      <a:r>
                        <a:rPr lang="en-US" sz="1100" b="0" dirty="0" err="1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Allophycocyanin</a:t>
                      </a: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Arial"/>
                          <a:ea typeface="Batang"/>
                          <a:cs typeface="Times New Roman"/>
                        </a:rPr>
                        <a:t> (APC)</a:t>
                      </a:r>
                      <a:endParaRPr lang="it-IT" sz="1100" b="1" dirty="0">
                        <a:latin typeface="Times New Roman"/>
                        <a:ea typeface="Batang"/>
                        <a:cs typeface="Times New Roman"/>
                      </a:endParaRPr>
                    </a:p>
                  </a:txBody>
                  <a:tcPr marL="61494" marR="614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76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Batang</vt:lpstr>
      <vt:lpstr>Arial</vt:lpstr>
      <vt:lpstr>Calibri</vt:lpstr>
      <vt:lpstr>Times New Roman</vt:lpstr>
      <vt:lpstr>Tema di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ab1</dc:creator>
  <cp:lastModifiedBy>Jaro, Dina</cp:lastModifiedBy>
  <cp:revision>5</cp:revision>
  <dcterms:created xsi:type="dcterms:W3CDTF">2017-01-24T15:49:50Z</dcterms:created>
  <dcterms:modified xsi:type="dcterms:W3CDTF">2017-03-22T22:41:38Z</dcterms:modified>
</cp:coreProperties>
</file>